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58"/>
  </p:normalViewPr>
  <p:slideViewPr>
    <p:cSldViewPr snapToGrid="0">
      <p:cViewPr varScale="1">
        <p:scale>
          <a:sx n="120" d="100"/>
          <a:sy n="120" d="100"/>
        </p:scale>
        <p:origin x="8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EDBDBB-4AE5-3BD7-2B70-603742FD92C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5B3089-06CD-7A28-8A73-777DC61F755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6431B1-A716-BB43-55EC-9CE28C4908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DD91A-098C-944E-8A47-069CB7590925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C807B9-21EE-5109-54BC-D02FD16330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B821C4-5D3B-627C-0285-C58938BD6E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6C19-4118-BA41-AB35-832EB2BA8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52679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E331E4-0B58-047F-D048-5E6AEB4C37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04CF9C-CD2D-0CA0-3195-A818C2A388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FEF1A4-51F5-D1A2-C8AC-8657EBC262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DD91A-098C-944E-8A47-069CB7590925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3A1845-FEA4-6FF1-CFA0-0D628E99AC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EC88B7-5E71-BE6C-EC45-5785BB4456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6C19-4118-BA41-AB35-832EB2BA8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9378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2555F77-50C1-190E-1297-215C1ED5BD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10C3AA7-AD63-F466-CEC0-9AB4B58973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83B821-0E28-E7A4-E6BE-D0866654DA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DD91A-098C-944E-8A47-069CB7590925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2FD48C-A93E-A6A4-E96E-159BE9FC10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0ABB7F-8EB8-DC00-5FE5-946E8E6296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6C19-4118-BA41-AB35-832EB2BA8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7579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6307E5-68A5-6EA2-832A-934C3DCFAB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48C8B8-ACFA-F8F8-0B12-EEC1759F6ED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9156A9-3947-59B3-F7FE-3E4A43B5E5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DD91A-098C-944E-8A47-069CB7590925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6CD897-A48D-C5BA-07B7-BBA7B5B36C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9D440F-9B60-3315-65C0-2984043B8B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6C19-4118-BA41-AB35-832EB2BA8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127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7B2C83-78A1-F674-874A-585C581C30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38A04C-044A-69F7-F26B-7763FEE55C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CF2451-D0C1-D6B8-BF36-492445285A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DD91A-098C-944E-8A47-069CB7590925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5FA200-3AC6-40B8-5817-029354EBE0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FF8EDC-0290-1E9F-F418-306925A0D1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6C19-4118-BA41-AB35-832EB2BA8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48733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03ED3B-E795-9208-2262-705F15F442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17F0FB-5CFF-4024-543B-5381019EEC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B65283D-7541-3B4D-EF4D-DF4C78048A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6DB803-9E4F-6723-1568-546231D314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DD91A-098C-944E-8A47-069CB7590925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BE9E91-0E04-A3DE-EE8B-A8F8C158F4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972553B-2F17-D73B-ABDF-9502415B56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6C19-4118-BA41-AB35-832EB2BA8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36479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DA7B3D-1581-4CA9-A01E-4C344DF55F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6BDFB0-E151-46BB-6680-849AD1717A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CA3FC71-70BF-0490-24FD-1613064DC8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309638B-A929-C6A3-CD81-68BEC246C21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60B5C3B-FFA2-4AF2-D534-8760E1841E0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8EB3758-6C9C-ADCD-8E5F-07C1B9166B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DD91A-098C-944E-8A47-069CB7590925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0CF7EC1-FE1B-2245-51C8-CD0D44A325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EEE8512-0F1D-D3A1-B7C2-A5DEF967BD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6C19-4118-BA41-AB35-832EB2BA8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0591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45CAB7-DEFC-1008-99C6-96587A77C5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1424AD8-D8A3-54D1-5607-4BE4D24370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DD91A-098C-944E-8A47-069CB7590925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59E95F5-A95C-7899-72EE-ECFD6A6697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AD47ADD-E311-A5A6-7CA8-CC5A270222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6C19-4118-BA41-AB35-832EB2BA8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35892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5C1BD9F-DE2D-EB01-D746-AB00E7BF91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DD91A-098C-944E-8A47-069CB7590925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F134172-A044-7917-9906-268113857E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1F95A07-7D00-6BE7-7278-E97E10F0E7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6C19-4118-BA41-AB35-832EB2BA8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92500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84FB11-2B3E-93EA-F315-7DAD100074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B31F55-34ED-7F6D-93DA-AAD1B7D1F2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5A039AC-820E-7BE2-E226-5218DB9DC4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CB26DF-51C4-F67B-A8DB-2FE090FA2D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DD91A-098C-944E-8A47-069CB7590925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3491AB-2809-D47E-85DC-5E75ADB7C8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F11631-7174-C018-0C75-B5E142F9DB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6C19-4118-BA41-AB35-832EB2BA8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5861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EBAD20-9F3D-0E8F-8F2A-279EC5A597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8906A67-6E95-A7D9-8B87-8D883498F0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A22A0E-D6E8-0E72-CC27-2B2124B016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35D1539-DC22-2AB7-3692-208A2EA8E0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1DD91A-098C-944E-8A47-069CB7590925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667BC4-886B-E60F-FED7-7C74AE38C6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28D877-C38B-346F-D12A-4D74285138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6C19-4118-BA41-AB35-832EB2BA8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6852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B15287A-EC4B-A77F-E21A-382C80AAB9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1C829C6-2920-A064-98DD-F1B0BA0016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652D60-8301-597A-92E0-4754DA376F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71DD91A-098C-944E-8A47-069CB7590925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17EE4A-5A5A-983F-C699-61E03323E9E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D315BF-1A51-C349-BD0D-85F34A7085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50E6C19-4118-BA41-AB35-832EB2BA82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286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3AC12F9-000B-A221-CDA1-EC3B4FEAC2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1333" y="111211"/>
            <a:ext cx="10489333" cy="608687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7FFB2EC-89A2-9835-55B0-F412B3DE24B1}"/>
              </a:ext>
            </a:extLst>
          </p:cNvPr>
          <p:cNvSpPr txBox="1"/>
          <p:nvPr/>
        </p:nvSpPr>
        <p:spPr>
          <a:xfrm>
            <a:off x="709867" y="6285124"/>
            <a:ext cx="1163453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7</a:t>
            </a:r>
            <a:r>
              <a:rPr lang="en-US" sz="12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 </a:t>
            </a:r>
            <a:r>
              <a:rPr lang="en-US" sz="1200" kern="100" dirty="0">
                <a:solidFill>
                  <a:schemeClr val="bg2">
                    <a:lumMod val="10000"/>
                  </a:schemeClr>
                </a:solidFill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Overall and Progression Free Survival Kaplan Meier curves for  the proteins DLST and  MSR1 based on serum pre CRT (baseline) data (present analysis) and in the CPTAC tissue proteome data. </a:t>
            </a:r>
            <a:endParaRPr lang="en-US" sz="1200" dirty="0">
              <a:solidFill>
                <a:schemeClr val="bg2">
                  <a:lumMod val="1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529875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9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rauze, Andra (NIH/NCI) [E]</dc:creator>
  <cp:lastModifiedBy>Krauze, Andra (NIH/NCI) [E]</cp:lastModifiedBy>
  <cp:revision>2</cp:revision>
  <dcterms:created xsi:type="dcterms:W3CDTF">2025-10-28T20:19:03Z</dcterms:created>
  <dcterms:modified xsi:type="dcterms:W3CDTF">2025-10-28T20:20:59Z</dcterms:modified>
</cp:coreProperties>
</file>